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38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640" y="52388"/>
            <a:ext cx="6143366" cy="438472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2546" y="4259411"/>
            <a:ext cx="8856984" cy="2769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3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300" b="1" smtClean="0">
                <a:latin typeface="Arial" panose="020B0604020202020204" pitchFamily="34" charset="0"/>
                <a:cs typeface="Arial" panose="020B0604020202020204" pitchFamily="34" charset="0"/>
              </a:rPr>
              <a:t>S10.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Frequency of abnormal cells in four types of autotetraploid rice hybrids during meiosis. E1-4x×E24-4x represent autotetraploid rice hybrid harboring pervasive interactions at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Sa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 pollen sterility loci. T449-4x×E1-4x and T449-4x×E24-4x have no-interaction at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Sb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pollen sterility loci, but interaction exists at </a:t>
            </a:r>
            <a:r>
              <a:rPr lang="en-US" altLang="zh-CN" sz="1300" i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pollen sterility locus. T449-4x×E245-4x has no-interaction at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Sb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300" i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pollen sterility loci. </a:t>
            </a:r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 Frequency of abnormal cells at Metaphase I stage. </a:t>
            </a:r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 Frequency of abnormal cells at Anaphase I stage. </a:t>
            </a:r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Frequency of abnormal cells at Telophase I stage. </a:t>
            </a:r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 Frequency of abnormal cells at Metaphase II stage. </a:t>
            </a:r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e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Frequency of abnormal cells at Anaphase II stage. </a:t>
            </a:r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 Frequency of abnormal cells at Telophase II stage. “**” indicates significant differences in three hybrids (T449-4x×E1-4x, T449-4x×E24-4x and T449-4x×E245-4x) compared to control hybrid (E1-4x×E24-4x). </a:t>
            </a:r>
            <a:endParaRPr lang="zh-CN" altLang="zh-CN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25875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2</cp:revision>
  <dcterms:modified xsi:type="dcterms:W3CDTF">2017-10-05T01:55:52Z</dcterms:modified>
</cp:coreProperties>
</file>